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30" d="100"/>
          <a:sy n="30" d="100"/>
        </p:scale>
        <p:origin x="-2528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b-NO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1220C-72D0-1846-AC63-2AC18F49B5B6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07D50-114B-0646-88E8-D0473B98C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76826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1220C-72D0-1846-AC63-2AC18F49B5B6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07D50-114B-0646-88E8-D0473B98C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3425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1220C-72D0-1846-AC63-2AC18F49B5B6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07D50-114B-0646-88E8-D0473B98C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4766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1220C-72D0-1846-AC63-2AC18F49B5B6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07D50-114B-0646-88E8-D0473B98C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7261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1220C-72D0-1846-AC63-2AC18F49B5B6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07D50-114B-0646-88E8-D0473B98C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4100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1220C-72D0-1846-AC63-2AC18F49B5B6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07D50-114B-0646-88E8-D0473B98C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2913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1220C-72D0-1846-AC63-2AC18F49B5B6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07D50-114B-0646-88E8-D0473B98C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4034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1220C-72D0-1846-AC63-2AC18F49B5B6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07D50-114B-0646-88E8-D0473B98C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30945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1220C-72D0-1846-AC63-2AC18F49B5B6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07D50-114B-0646-88E8-D0473B98C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9215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1220C-72D0-1846-AC63-2AC18F49B5B6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07D50-114B-0646-88E8-D0473B98C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10707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1220C-72D0-1846-AC63-2AC18F49B5B6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07D50-114B-0646-88E8-D0473B98C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10623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51220C-72D0-1846-AC63-2AC18F49B5B6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07D50-114B-0646-88E8-D0473B98C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5442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17986477"/>
              </p:ext>
            </p:extLst>
          </p:nvPr>
        </p:nvGraphicFramePr>
        <p:xfrm>
          <a:off x="628493" y="585966"/>
          <a:ext cx="7887014" cy="4457700"/>
        </p:xfrm>
        <a:graphic>
          <a:graphicData uri="http://schemas.openxmlformats.org/drawingml/2006/table">
            <a:tbl>
              <a:tblPr firstRow="1" bandRow="1">
                <a:effectLst/>
                <a:tableStyleId>{5940675A-B579-460E-94D1-54222C63F5DA}</a:tableStyleId>
              </a:tblPr>
              <a:tblGrid>
                <a:gridCol w="90200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90200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52075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52075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52075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52075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</a:tblGrid>
              <a:tr h="370840">
                <a:tc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Stress Regime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Female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Stress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Recovery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wt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Epac1</a:t>
                      </a:r>
                      <a:r>
                        <a:rPr lang="en-US" sz="1200" b="1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Epac2</a:t>
                      </a:r>
                      <a:r>
                        <a:rPr lang="en-US" sz="1200" b="1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Epac1/2</a:t>
                      </a:r>
                      <a:r>
                        <a:rPr lang="en-US" sz="1200" b="1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No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No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 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080.16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790.13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330.10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100.17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0h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280.21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220.21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710.15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370.11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440.13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100.16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710.16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300.14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hr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240.12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900.09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470.11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950.12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370840">
                <a:tc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Stress Regimen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Male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 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Stress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Recovery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wt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Epac1</a:t>
                      </a:r>
                      <a:r>
                        <a:rPr lang="en-US" sz="1200" b="1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Epac2</a:t>
                      </a:r>
                      <a:r>
                        <a:rPr lang="en-US" sz="1200" b="1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Epac1/2</a:t>
                      </a:r>
                      <a:r>
                        <a:rPr lang="en-US" sz="1200" b="1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No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No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 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00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03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980.11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990.09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900.07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0h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050.11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980.09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090.14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800.10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820.06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920.06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850.07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610.04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hr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930.07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780.07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840.11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720.06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4190" y="9160"/>
            <a:ext cx="11124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S4 </a:t>
            </a:r>
            <a:r>
              <a:rPr lang="en-US" sz="1600" b="1" dirty="0">
                <a:latin typeface="Times New Roman"/>
                <a:cs typeface="Times New Roman"/>
              </a:rPr>
              <a:t>Table</a:t>
            </a:r>
            <a:endParaRPr lang="en-US" sz="1600" b="1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4190" y="5437460"/>
            <a:ext cx="751114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S4 </a:t>
            </a:r>
            <a:r>
              <a:rPr lang="en-US" sz="1400" b="1" dirty="0" smtClean="0">
                <a:latin typeface="Times New Roman"/>
                <a:cs typeface="Times New Roman"/>
              </a:rPr>
              <a:t>Table. </a:t>
            </a:r>
            <a:r>
              <a:rPr lang="en-US" sz="1400" b="1" dirty="0">
                <a:latin typeface="Times New Roman"/>
                <a:cs typeface="Times New Roman"/>
              </a:rPr>
              <a:t>Comparison of GR mRNA levels </a:t>
            </a:r>
            <a:r>
              <a:rPr lang="en-US" sz="1400" b="1" dirty="0" smtClean="0">
                <a:latin typeface="Times New Roman"/>
                <a:cs typeface="Times New Roman"/>
              </a:rPr>
              <a:t>in </a:t>
            </a:r>
            <a:r>
              <a:rPr lang="en-US" sz="1400" b="1" dirty="0">
                <a:latin typeface="Times New Roman"/>
                <a:cs typeface="Times New Roman"/>
              </a:rPr>
              <a:t>unstressed </a:t>
            </a:r>
            <a:r>
              <a:rPr lang="en-US" sz="1400" b="1" i="1" dirty="0" smtClean="0">
                <a:latin typeface="Times New Roman"/>
                <a:cs typeface="Times New Roman"/>
              </a:rPr>
              <a:t>vs. </a:t>
            </a:r>
            <a:r>
              <a:rPr lang="en-US" sz="1400" b="1" dirty="0">
                <a:latin typeface="Times New Roman"/>
                <a:cs typeface="Times New Roman"/>
              </a:rPr>
              <a:t>stressed mice</a:t>
            </a:r>
            <a:r>
              <a:rPr lang="en-US" sz="1400" b="1" dirty="0" smtClean="0">
                <a:latin typeface="Times New Roman"/>
                <a:cs typeface="Times New Roman"/>
              </a:rPr>
              <a:t>.</a:t>
            </a:r>
            <a:endParaRPr lang="en-US" sz="1400" dirty="0">
              <a:latin typeface="Times New Roman"/>
              <a:cs typeface="Times New Roman"/>
            </a:endParaRPr>
          </a:p>
          <a:p>
            <a:pPr algn="just"/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4378949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7</Words>
  <Application>Microsoft Macintosh PowerPoint</Application>
  <PresentationFormat>On-screen Show (4:3)</PresentationFormat>
  <Paragraphs>6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i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hrine Sivertsen Åsrud</dc:creator>
  <cp:lastModifiedBy>Kathrine Sivertsen Åsrud</cp:lastModifiedBy>
  <cp:revision>1</cp:revision>
  <dcterms:created xsi:type="dcterms:W3CDTF">2018-03-05T13:39:46Z</dcterms:created>
  <dcterms:modified xsi:type="dcterms:W3CDTF">2018-03-05T13:40:03Z</dcterms:modified>
</cp:coreProperties>
</file>